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1320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E59B4-080E-44CE-95EB-73E5F092B16B}" type="datetimeFigureOut">
              <a:rPr lang="en-US" smtClean="0"/>
              <a:t>9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DF17-7054-42FA-8E8D-DBEA44EF1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779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E59B4-080E-44CE-95EB-73E5F092B16B}" type="datetimeFigureOut">
              <a:rPr lang="en-US" smtClean="0"/>
              <a:t>9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DF17-7054-42FA-8E8D-DBEA44EF1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144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E59B4-080E-44CE-95EB-73E5F092B16B}" type="datetimeFigureOut">
              <a:rPr lang="en-US" smtClean="0"/>
              <a:t>9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DF17-7054-42FA-8E8D-DBEA44EF1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3362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E59B4-080E-44CE-95EB-73E5F092B16B}" type="datetimeFigureOut">
              <a:rPr lang="en-US" smtClean="0"/>
              <a:t>9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DF17-7054-42FA-8E8D-DBEA44EF1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8664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E59B4-080E-44CE-95EB-73E5F092B16B}" type="datetimeFigureOut">
              <a:rPr lang="en-US" smtClean="0"/>
              <a:t>9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DF17-7054-42FA-8E8D-DBEA44EF1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7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E59B4-080E-44CE-95EB-73E5F092B16B}" type="datetimeFigureOut">
              <a:rPr lang="en-US" smtClean="0"/>
              <a:t>9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DF17-7054-42FA-8E8D-DBEA44EF1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860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E59B4-080E-44CE-95EB-73E5F092B16B}" type="datetimeFigureOut">
              <a:rPr lang="en-US" smtClean="0"/>
              <a:t>9/1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DF17-7054-42FA-8E8D-DBEA44EF1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331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E59B4-080E-44CE-95EB-73E5F092B16B}" type="datetimeFigureOut">
              <a:rPr lang="en-US" smtClean="0"/>
              <a:t>9/1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DF17-7054-42FA-8E8D-DBEA44EF1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5104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E59B4-080E-44CE-95EB-73E5F092B16B}" type="datetimeFigureOut">
              <a:rPr lang="en-US" smtClean="0"/>
              <a:t>9/1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DF17-7054-42FA-8E8D-DBEA44EF1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6823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E59B4-080E-44CE-95EB-73E5F092B16B}" type="datetimeFigureOut">
              <a:rPr lang="en-US" smtClean="0"/>
              <a:t>9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DF17-7054-42FA-8E8D-DBEA44EF1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68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E59B4-080E-44CE-95EB-73E5F092B16B}" type="datetimeFigureOut">
              <a:rPr lang="en-US" smtClean="0"/>
              <a:t>9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CDF17-7054-42FA-8E8D-DBEA44EF1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674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1E59B4-080E-44CE-95EB-73E5F092B16B}" type="datetimeFigureOut">
              <a:rPr lang="en-US" smtClean="0"/>
              <a:t>9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6CDF17-7054-42FA-8E8D-DBEA44EF1F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00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1685640"/>
            <a:ext cx="3682301" cy="264544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5400" y="1685639"/>
            <a:ext cx="3682302" cy="264544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62000" y="838200"/>
            <a:ext cx="7171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1: Linkage disequilibrium (LD) plots for common </a:t>
            </a:r>
            <a:r>
              <a:rPr lang="en-US" b="1" i="1" dirty="0"/>
              <a:t>NOTCH3</a:t>
            </a:r>
            <a:r>
              <a:rPr lang="en-US" b="1" dirty="0"/>
              <a:t> </a:t>
            </a:r>
            <a:r>
              <a:rPr lang="en-US" b="1" dirty="0" smtClean="0"/>
              <a:t>variants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62000" y="4953000"/>
            <a:ext cx="7579639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igure S1</a:t>
            </a:r>
            <a:r>
              <a:rPr lang="en-US" sz="1200" dirty="0" smtClean="0"/>
              <a:t>: Display the patterns for linkage disequilibrium (LD) for common NOTCH3 variants as assessed </a:t>
            </a:r>
          </a:p>
          <a:p>
            <a:r>
              <a:rPr lang="en-US" sz="1200" dirty="0" smtClean="0"/>
              <a:t>for (A) Caucasian and (B) African American control series collected through the ISGS study. LD were generated through </a:t>
            </a:r>
          </a:p>
          <a:p>
            <a:r>
              <a:rPr lang="en-US" sz="1200" dirty="0" smtClean="0"/>
              <a:t>the </a:t>
            </a:r>
            <a:r>
              <a:rPr lang="en-US" sz="1200" dirty="0" err="1" smtClean="0"/>
              <a:t>Haploview</a:t>
            </a:r>
            <a:r>
              <a:rPr lang="en-US" sz="1200" dirty="0" smtClean="0"/>
              <a:t> software package</a:t>
            </a:r>
            <a:r>
              <a:rPr lang="en-US" sz="1200" baseline="30000" dirty="0"/>
              <a:t>*</a:t>
            </a:r>
            <a:r>
              <a:rPr lang="en-US" sz="1200" dirty="0" smtClean="0"/>
              <a:t> and LD values and color scheme are shown for r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-values.</a:t>
            </a:r>
          </a:p>
          <a:p>
            <a:endParaRPr lang="en-US" sz="1200" dirty="0"/>
          </a:p>
          <a:p>
            <a:endParaRPr lang="en-US" sz="1200" dirty="0" smtClean="0"/>
          </a:p>
          <a:p>
            <a:r>
              <a:rPr lang="en-US" sz="1200" i="1" baseline="30000" dirty="0" smtClean="0"/>
              <a:t>*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Barrett JC, Fry B,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Maller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 J, Daly MJ.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Haploview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: analysis and visualization of LD and haplotype maps. Bioinformatics. </a:t>
            </a:r>
          </a:p>
          <a:p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2005 Jan 15 [PubMed ID: 15297300] 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sz="1200" baseline="30000" dirty="0"/>
          </a:p>
        </p:txBody>
      </p:sp>
      <p:sp>
        <p:nvSpPr>
          <p:cNvPr id="8" name="TextBox 7"/>
          <p:cNvSpPr txBox="1"/>
          <p:nvPr/>
        </p:nvSpPr>
        <p:spPr>
          <a:xfrm>
            <a:off x="385230" y="1683056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4728630" y="1715543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70336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09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ddy</dc:creator>
  <cp:lastModifiedBy>Owen A Ross</cp:lastModifiedBy>
  <cp:revision>4</cp:revision>
  <dcterms:created xsi:type="dcterms:W3CDTF">2013-03-19T16:12:29Z</dcterms:created>
  <dcterms:modified xsi:type="dcterms:W3CDTF">2013-09-10T19:16:49Z</dcterms:modified>
</cp:coreProperties>
</file>